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12801600" cy="96012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7AC71D-967F-4F6C-98D5-29646DA144A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39720" y="383760"/>
            <a:ext cx="11522160" cy="160020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ctr">
            <a:noAutofit/>
          </a:bodyPr>
          <a:p>
            <a:pPr indent="0" algn="ctr">
              <a:buNone/>
              <a:tabLst>
                <a:tab algn="l" pos="0"/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39720" y="2239920"/>
            <a:ext cx="11522160" cy="302292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t">
            <a:normAutofit/>
          </a:bodyPr>
          <a:p>
            <a:pPr indent="0">
              <a:spcBef>
                <a:spcPts val="1125"/>
              </a:spcBef>
              <a:buNone/>
              <a:tabLst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39720" y="5550480"/>
            <a:ext cx="11522160" cy="302292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t">
            <a:normAutofit/>
          </a:bodyPr>
          <a:p>
            <a:pPr indent="0">
              <a:spcBef>
                <a:spcPts val="1125"/>
              </a:spcBef>
              <a:buNone/>
              <a:tabLst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9BE43D-53C8-4873-AED8-59C4F0D14D1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39720" y="383760"/>
            <a:ext cx="11522160" cy="160020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ctr">
            <a:noAutofit/>
          </a:bodyPr>
          <a:p>
            <a:pPr indent="0" algn="ctr">
              <a:buNone/>
              <a:tabLst>
                <a:tab algn="l" pos="0"/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39720" y="2239920"/>
            <a:ext cx="5622480" cy="302292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t">
            <a:normAutofit/>
          </a:bodyPr>
          <a:p>
            <a:pPr indent="0">
              <a:spcBef>
                <a:spcPts val="1125"/>
              </a:spcBef>
              <a:buNone/>
              <a:tabLst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6543720" y="2239920"/>
            <a:ext cx="5622480" cy="302292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t">
            <a:normAutofit/>
          </a:bodyPr>
          <a:p>
            <a:pPr indent="0">
              <a:spcBef>
                <a:spcPts val="1125"/>
              </a:spcBef>
              <a:buNone/>
              <a:tabLst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39720" y="5550480"/>
            <a:ext cx="5622480" cy="302292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t">
            <a:normAutofit/>
          </a:bodyPr>
          <a:p>
            <a:pPr indent="0">
              <a:spcBef>
                <a:spcPts val="1125"/>
              </a:spcBef>
              <a:buNone/>
              <a:tabLst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6543720" y="5550480"/>
            <a:ext cx="5622480" cy="302292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t">
            <a:normAutofit/>
          </a:bodyPr>
          <a:p>
            <a:pPr indent="0">
              <a:spcBef>
                <a:spcPts val="1125"/>
              </a:spcBef>
              <a:buNone/>
              <a:tabLst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857D42-7619-4B9D-9F89-409D9536ECE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39720" y="383760"/>
            <a:ext cx="11522160" cy="160020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ctr">
            <a:noAutofit/>
          </a:bodyPr>
          <a:p>
            <a:pPr indent="0" algn="ctr">
              <a:buNone/>
              <a:tabLst>
                <a:tab algn="l" pos="0"/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39720" y="2239920"/>
            <a:ext cx="3709800" cy="302292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t">
            <a:normAutofit/>
          </a:bodyPr>
          <a:p>
            <a:pPr indent="0">
              <a:spcBef>
                <a:spcPts val="1125"/>
              </a:spcBef>
              <a:buNone/>
              <a:tabLst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535280" y="2239920"/>
            <a:ext cx="3709800" cy="302292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t">
            <a:normAutofit/>
          </a:bodyPr>
          <a:p>
            <a:pPr indent="0">
              <a:spcBef>
                <a:spcPts val="1125"/>
              </a:spcBef>
              <a:buNone/>
              <a:tabLst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8431200" y="2239920"/>
            <a:ext cx="3709800" cy="302292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t">
            <a:normAutofit/>
          </a:bodyPr>
          <a:p>
            <a:pPr indent="0">
              <a:spcBef>
                <a:spcPts val="1125"/>
              </a:spcBef>
              <a:buNone/>
              <a:tabLst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39720" y="5550480"/>
            <a:ext cx="3709800" cy="302292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t">
            <a:normAutofit/>
          </a:bodyPr>
          <a:p>
            <a:pPr indent="0">
              <a:spcBef>
                <a:spcPts val="1125"/>
              </a:spcBef>
              <a:buNone/>
              <a:tabLst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535280" y="5550480"/>
            <a:ext cx="3709800" cy="302292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t">
            <a:normAutofit/>
          </a:bodyPr>
          <a:p>
            <a:pPr indent="0">
              <a:spcBef>
                <a:spcPts val="1125"/>
              </a:spcBef>
              <a:buNone/>
              <a:tabLst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8431200" y="5550480"/>
            <a:ext cx="3709800" cy="302292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t">
            <a:normAutofit/>
          </a:bodyPr>
          <a:p>
            <a:pPr indent="0">
              <a:spcBef>
                <a:spcPts val="1125"/>
              </a:spcBef>
              <a:buNone/>
              <a:tabLst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52C77B-4217-4D5A-B400-8726EDD2188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39720" y="383760"/>
            <a:ext cx="11522160" cy="160020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ctr">
            <a:noAutofit/>
          </a:bodyPr>
          <a:p>
            <a:pPr indent="0" algn="ctr">
              <a:buNone/>
              <a:tabLst>
                <a:tab algn="l" pos="0"/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39720" y="2239920"/>
            <a:ext cx="11522160" cy="6337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1125"/>
              </a:spcBef>
              <a:buNone/>
              <a:tabLst>
                <a:tab algn="l" pos="0"/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810098-36A5-4372-B55E-E5C0D44F888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39720" y="383760"/>
            <a:ext cx="11522160" cy="160020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ctr">
            <a:noAutofit/>
          </a:bodyPr>
          <a:p>
            <a:pPr indent="0" algn="ctr">
              <a:buNone/>
              <a:tabLst>
                <a:tab algn="l" pos="0"/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39720" y="2239920"/>
            <a:ext cx="11522160" cy="633744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t">
            <a:normAutofit/>
          </a:bodyPr>
          <a:p>
            <a:pPr indent="0">
              <a:spcBef>
                <a:spcPts val="1125"/>
              </a:spcBef>
              <a:buNone/>
              <a:tabLst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7DFB3B-C410-4469-AD54-86F9166F53C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39720" y="383760"/>
            <a:ext cx="11522160" cy="160020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ctr">
            <a:noAutofit/>
          </a:bodyPr>
          <a:p>
            <a:pPr indent="0" algn="ctr">
              <a:buNone/>
              <a:tabLst>
                <a:tab algn="l" pos="0"/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39720" y="2239920"/>
            <a:ext cx="5622480" cy="633744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t">
            <a:normAutofit/>
          </a:bodyPr>
          <a:p>
            <a:pPr indent="0">
              <a:spcBef>
                <a:spcPts val="1125"/>
              </a:spcBef>
              <a:buNone/>
              <a:tabLst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6543720" y="2239920"/>
            <a:ext cx="5622480" cy="633744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t">
            <a:normAutofit/>
          </a:bodyPr>
          <a:p>
            <a:pPr indent="0">
              <a:spcBef>
                <a:spcPts val="1125"/>
              </a:spcBef>
              <a:buNone/>
              <a:tabLst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A83140-7A8F-4898-B0E9-326B9C9F85A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39720" y="383760"/>
            <a:ext cx="11522160" cy="160020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ctr">
            <a:noAutofit/>
          </a:bodyPr>
          <a:p>
            <a:pPr indent="0" algn="ctr">
              <a:buNone/>
              <a:tabLst>
                <a:tab algn="l" pos="0"/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B132B1-6011-4A54-A68F-9777F001AC3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39720" y="383760"/>
            <a:ext cx="11522160" cy="7418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1125"/>
              </a:spcBef>
              <a:tabLst>
                <a:tab algn="l" pos="0"/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6F96FF-9630-4C7D-A351-9EF73DED7BE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39720" y="383760"/>
            <a:ext cx="11522160" cy="160020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ctr">
            <a:noAutofit/>
          </a:bodyPr>
          <a:p>
            <a:pPr indent="0" algn="ctr">
              <a:buNone/>
              <a:tabLst>
                <a:tab algn="l" pos="0"/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39720" y="2239920"/>
            <a:ext cx="5622480" cy="302292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t">
            <a:normAutofit/>
          </a:bodyPr>
          <a:p>
            <a:pPr indent="0">
              <a:spcBef>
                <a:spcPts val="1125"/>
              </a:spcBef>
              <a:buNone/>
              <a:tabLst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6543720" y="2239920"/>
            <a:ext cx="5622480" cy="633744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t">
            <a:normAutofit/>
          </a:bodyPr>
          <a:p>
            <a:pPr indent="0">
              <a:spcBef>
                <a:spcPts val="1125"/>
              </a:spcBef>
              <a:buNone/>
              <a:tabLst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39720" y="5550480"/>
            <a:ext cx="5622480" cy="302292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t">
            <a:normAutofit/>
          </a:bodyPr>
          <a:p>
            <a:pPr indent="0">
              <a:spcBef>
                <a:spcPts val="1125"/>
              </a:spcBef>
              <a:buNone/>
              <a:tabLst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E65B9B-3805-4FE9-B195-5B9F61A6DFA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39720" y="383760"/>
            <a:ext cx="11522160" cy="160020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ctr">
            <a:noAutofit/>
          </a:bodyPr>
          <a:p>
            <a:pPr indent="0" algn="ctr">
              <a:buNone/>
              <a:tabLst>
                <a:tab algn="l" pos="0"/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39720" y="2239920"/>
            <a:ext cx="5622480" cy="633744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t">
            <a:normAutofit/>
          </a:bodyPr>
          <a:p>
            <a:pPr indent="0">
              <a:spcBef>
                <a:spcPts val="1125"/>
              </a:spcBef>
              <a:buNone/>
              <a:tabLst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6543720" y="2239920"/>
            <a:ext cx="5622480" cy="302292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t">
            <a:normAutofit/>
          </a:bodyPr>
          <a:p>
            <a:pPr indent="0">
              <a:spcBef>
                <a:spcPts val="1125"/>
              </a:spcBef>
              <a:buNone/>
              <a:tabLst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6543720" y="5550480"/>
            <a:ext cx="5622480" cy="302292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t">
            <a:normAutofit/>
          </a:bodyPr>
          <a:p>
            <a:pPr indent="0">
              <a:spcBef>
                <a:spcPts val="1125"/>
              </a:spcBef>
              <a:buNone/>
              <a:tabLst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5167C8-0680-40BE-A44B-89311866161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39720" y="383760"/>
            <a:ext cx="11522160" cy="160020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ctr">
            <a:noAutofit/>
          </a:bodyPr>
          <a:p>
            <a:pPr indent="0" algn="ctr">
              <a:buNone/>
              <a:tabLst>
                <a:tab algn="l" pos="0"/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39720" y="2239920"/>
            <a:ext cx="5622480" cy="302292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t">
            <a:normAutofit/>
          </a:bodyPr>
          <a:p>
            <a:pPr indent="0">
              <a:spcBef>
                <a:spcPts val="1125"/>
              </a:spcBef>
              <a:buNone/>
              <a:tabLst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6543720" y="2239920"/>
            <a:ext cx="5622480" cy="302292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t">
            <a:normAutofit/>
          </a:bodyPr>
          <a:p>
            <a:pPr indent="0">
              <a:spcBef>
                <a:spcPts val="1125"/>
              </a:spcBef>
              <a:buNone/>
              <a:tabLst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39720" y="5550480"/>
            <a:ext cx="11522160" cy="302292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t">
            <a:normAutofit/>
          </a:bodyPr>
          <a:p>
            <a:pPr indent="0">
              <a:spcBef>
                <a:spcPts val="1125"/>
              </a:spcBef>
              <a:buNone/>
              <a:tabLst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7DD920-5AC6-487B-982C-20107B42316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39720" y="383760"/>
            <a:ext cx="11522160" cy="160020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ctr">
            <a:noAutofit/>
          </a:bodyPr>
          <a:p>
            <a:pPr indent="0" algn="ctr">
              <a:buNone/>
              <a:tabLst>
                <a:tab algn="l" pos="0"/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r>
              <a:rPr b="0" lang="en-US" sz="62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39720" y="2239920"/>
            <a:ext cx="11522160" cy="633744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t">
            <a:normAutofit/>
          </a:bodyPr>
          <a:p>
            <a:pPr marL="479520" indent="-479520">
              <a:spcBef>
                <a:spcPts val="1125"/>
              </a:spcBef>
              <a:buClr>
                <a:srgbClr val="000000"/>
              </a:buClr>
              <a:buFont typeface="Arial"/>
              <a:buChar char="•"/>
              <a:tabLst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r>
              <a:rPr b="0" lang="en-US" sz="45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  <a:p>
            <a:pPr lvl="1" marL="1039680" indent="-399960">
              <a:spcBef>
                <a:spcPts val="1125"/>
              </a:spcBef>
              <a:buClr>
                <a:srgbClr val="000000"/>
              </a:buClr>
              <a:buFont typeface="Arial"/>
              <a:buChar char="–"/>
              <a:tabLst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r>
              <a:rPr b="0" lang="en-US" sz="45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  <a:p>
            <a:pPr lvl="2" marL="1600200" indent="-318960">
              <a:spcBef>
                <a:spcPts val="1125"/>
              </a:spcBef>
              <a:buClr>
                <a:srgbClr val="000000"/>
              </a:buClr>
              <a:buFont typeface="Arial"/>
              <a:buChar char="•"/>
              <a:tabLst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r>
              <a:rPr b="0" lang="en-US" sz="45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  <a:p>
            <a:pPr lvl="3" marL="2239920" indent="-318960">
              <a:spcBef>
                <a:spcPts val="1125"/>
              </a:spcBef>
              <a:buClr>
                <a:srgbClr val="000000"/>
              </a:buClr>
              <a:buFont typeface="Arial"/>
              <a:buChar char="–"/>
              <a:tabLst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r>
              <a:rPr b="0" lang="en-US" sz="45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  <a:p>
            <a:pPr lvl="4" marL="2879640" indent="-318960">
              <a:spcBef>
                <a:spcPts val="1125"/>
              </a:spcBef>
              <a:buClr>
                <a:srgbClr val="000000"/>
              </a:buClr>
              <a:buFont typeface="Arial"/>
              <a:buChar char="»"/>
              <a:tabLst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r>
              <a:rPr b="0" lang="en-US" sz="45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  <a:p>
            <a:pPr lvl="5" marL="2879640" indent="-318960">
              <a:spcBef>
                <a:spcPts val="1125"/>
              </a:spcBef>
              <a:buClr>
                <a:srgbClr val="000000"/>
              </a:buClr>
              <a:buFont typeface="Arial"/>
              <a:buChar char="»"/>
              <a:tabLst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r>
              <a:rPr b="0" lang="en-US" sz="45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  <a:p>
            <a:pPr lvl="6" marL="2879640" indent="-318960">
              <a:spcBef>
                <a:spcPts val="1125"/>
              </a:spcBef>
              <a:buClr>
                <a:srgbClr val="000000"/>
              </a:buClr>
              <a:buFont typeface="Arial"/>
              <a:buChar char="»"/>
              <a:tabLst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r>
              <a:rPr b="0" lang="en-US" sz="45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4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39360" y="8899560"/>
            <a:ext cx="2987640" cy="51120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  <a:defRPr b="0" lang="ja-JP" sz="17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fld id="{7686F974-AAC9-4930-84BD-1E08CC3DAB9A}" type="datetime">
              <a:rPr b="0" lang="ja-JP" sz="1700" spc="-1" strike="noStrike">
                <a:solidFill>
                  <a:srgbClr val="898989"/>
                </a:solidFill>
                <a:latin typeface="Calibri"/>
              </a:rPr>
              <a:t>26/08/29</a:t>
            </a:fld>
            <a:endParaRPr b="0" lang="en-US" sz="1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373640" y="8899560"/>
            <a:ext cx="4054320" cy="51120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ctr">
            <a:noAutofit/>
          </a:bodyPr>
          <a:p>
            <a:pPr indent="0">
              <a:buNone/>
              <a:tabLst>
                <a:tab algn="l" pos="0"/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9173880" y="8899560"/>
            <a:ext cx="2987640" cy="511200"/>
          </a:xfrm>
          <a:prstGeom prst="rect">
            <a:avLst/>
          </a:prstGeom>
          <a:noFill/>
          <a:ln w="0">
            <a:noFill/>
          </a:ln>
        </p:spPr>
        <p:txBody>
          <a:bodyPr lIns="128160" rIns="128160" tIns="64080" bIns="6408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  <a:defRPr b="0" lang="ja-JP" sz="17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fld id="{0A9B6538-08E5-4743-9836-1C1B110535FA}" type="slidenum">
              <a:rPr b="0" lang="ja-JP" sz="17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7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グラフ 3" descr=""/>
          <p:cNvPicPr/>
          <p:nvPr/>
        </p:nvPicPr>
        <p:blipFill>
          <a:blip r:embed="rId1"/>
          <a:stretch/>
        </p:blipFill>
        <p:spPr>
          <a:xfrm>
            <a:off x="1652760" y="426960"/>
            <a:ext cx="9874080" cy="4599000"/>
          </a:xfrm>
          <a:prstGeom prst="rect">
            <a:avLst/>
          </a:prstGeom>
          <a:ln w="0">
            <a:noFill/>
          </a:ln>
        </p:spPr>
      </p:pic>
      <p:sp>
        <p:nvSpPr>
          <p:cNvPr id="42" name="テキスト ボックス 4"/>
          <p:cNvSpPr/>
          <p:nvPr/>
        </p:nvSpPr>
        <p:spPr>
          <a:xfrm>
            <a:off x="2637720" y="504720"/>
            <a:ext cx="916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92.00 %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テキスト ボックス 5"/>
          <p:cNvSpPr/>
          <p:nvPr/>
        </p:nvSpPr>
        <p:spPr>
          <a:xfrm>
            <a:off x="8587800" y="504720"/>
            <a:ext cx="801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1.41 %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テキスト ボックス 6"/>
          <p:cNvSpPr/>
          <p:nvPr/>
        </p:nvSpPr>
        <p:spPr>
          <a:xfrm>
            <a:off x="7048800" y="504720"/>
            <a:ext cx="916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23.36 %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テキスト ボックス 7"/>
          <p:cNvSpPr/>
          <p:nvPr/>
        </p:nvSpPr>
        <p:spPr>
          <a:xfrm>
            <a:off x="5608080" y="504720"/>
            <a:ext cx="801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3.80 %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テキスト ボックス 8"/>
          <p:cNvSpPr/>
          <p:nvPr/>
        </p:nvSpPr>
        <p:spPr>
          <a:xfrm>
            <a:off x="4049280" y="504720"/>
            <a:ext cx="916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14.19 %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テキスト ボックス 9"/>
          <p:cNvSpPr/>
          <p:nvPr/>
        </p:nvSpPr>
        <p:spPr>
          <a:xfrm rot="16200000">
            <a:off x="741600" y="2216520"/>
            <a:ext cx="14364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Cell number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円/楕円 10"/>
          <p:cNvSpPr/>
          <p:nvPr/>
        </p:nvSpPr>
        <p:spPr>
          <a:xfrm>
            <a:off x="1682640" y="5465880"/>
            <a:ext cx="4756320" cy="2501640"/>
          </a:xfrm>
          <a:prstGeom prst="ellipse">
            <a:avLst/>
          </a:prstGeom>
          <a:solidFill>
            <a:srgbClr val="b8bd1e">
              <a:alpha val="20000"/>
            </a:srgbClr>
          </a:solidFill>
          <a:ln w="9360">
            <a:solidFill>
              <a:srgbClr val="00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円/楕円 11"/>
          <p:cNvSpPr/>
          <p:nvPr/>
        </p:nvSpPr>
        <p:spPr>
          <a:xfrm>
            <a:off x="5703840" y="5465880"/>
            <a:ext cx="4754520" cy="2501640"/>
          </a:xfrm>
          <a:prstGeom prst="ellipse">
            <a:avLst/>
          </a:prstGeom>
          <a:solidFill>
            <a:srgbClr val="bd38a6">
              <a:alpha val="20000"/>
            </a:srgbClr>
          </a:solidFill>
          <a:ln w="9360">
            <a:solidFill>
              <a:srgbClr val="00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円/楕円 12"/>
          <p:cNvSpPr/>
          <p:nvPr/>
        </p:nvSpPr>
        <p:spPr>
          <a:xfrm>
            <a:off x="2670120" y="6040440"/>
            <a:ext cx="6764400" cy="3041640"/>
          </a:xfrm>
          <a:prstGeom prst="ellipse">
            <a:avLst/>
          </a:prstGeom>
          <a:solidFill>
            <a:srgbClr val="4d53bd">
              <a:alpha val="20000"/>
            </a:srgbClr>
          </a:solidFill>
          <a:ln w="9360">
            <a:solidFill>
              <a:srgbClr val="00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テキスト ボックス 13"/>
          <p:cNvSpPr/>
          <p:nvPr/>
        </p:nvSpPr>
        <p:spPr>
          <a:xfrm>
            <a:off x="8400960" y="5826240"/>
            <a:ext cx="141948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Calibri"/>
              </a:rPr>
              <a:t>MLLT3: </a:t>
            </a:r>
            <a:r>
              <a:rPr b="0" lang="en-US" sz="3600" spc="-1" strike="noStrike">
                <a:solidFill>
                  <a:srgbClr val="000000"/>
                </a:solidFill>
                <a:latin typeface="Calibri"/>
              </a:rPr>
              <a:t>7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テキスト ボックス 14"/>
          <p:cNvSpPr/>
          <p:nvPr/>
        </p:nvSpPr>
        <p:spPr>
          <a:xfrm>
            <a:off x="2471760" y="5826240"/>
            <a:ext cx="116676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Calibri"/>
              </a:rPr>
              <a:t>MYB: </a:t>
            </a:r>
            <a:r>
              <a:rPr b="0" lang="en-US" sz="3600" spc="-1" strike="noStrike">
                <a:solidFill>
                  <a:srgbClr val="000000"/>
                </a:solidFill>
                <a:latin typeface="Calibri"/>
              </a:rPr>
              <a:t>5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テキスト ボックス 15"/>
          <p:cNvSpPr/>
          <p:nvPr/>
        </p:nvSpPr>
        <p:spPr>
          <a:xfrm>
            <a:off x="4021560" y="8024760"/>
            <a:ext cx="400752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Calibri"/>
              </a:rPr>
              <a:t>MYB &amp; MLLT3 double KD: </a:t>
            </a:r>
            <a:r>
              <a:rPr b="0" lang="en-US" sz="3600" spc="-1" strike="noStrike">
                <a:solidFill>
                  <a:srgbClr val="000000"/>
                </a:solidFill>
                <a:latin typeface="Calibri"/>
              </a:rPr>
              <a:t>27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正方形/長方形 16"/>
          <p:cNvSpPr/>
          <p:nvPr/>
        </p:nvSpPr>
        <p:spPr>
          <a:xfrm>
            <a:off x="7470000" y="6673680"/>
            <a:ext cx="64404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Calibri"/>
              </a:rPr>
              <a:t>11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正方形/長方形 17"/>
          <p:cNvSpPr/>
          <p:nvPr/>
        </p:nvSpPr>
        <p:spPr>
          <a:xfrm>
            <a:off x="4144320" y="6673680"/>
            <a:ext cx="64404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Calibri"/>
              </a:rPr>
              <a:t>12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正方形/長方形 18"/>
          <p:cNvSpPr/>
          <p:nvPr/>
        </p:nvSpPr>
        <p:spPr>
          <a:xfrm>
            <a:off x="5838840" y="6299280"/>
            <a:ext cx="41220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Calibri"/>
              </a:rPr>
              <a:t>4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Rectangle 25"/>
          <p:cNvSpPr/>
          <p:nvPr/>
        </p:nvSpPr>
        <p:spPr>
          <a:xfrm>
            <a:off x="-33840" y="4819680"/>
            <a:ext cx="12993120" cy="402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28160" rIns="128160" tIns="64080" bIns="6408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279440"/>
                <a:tab algn="l" pos="2558880"/>
                <a:tab algn="l" pos="3838680"/>
                <a:tab algn="l" pos="5118120"/>
                <a:tab algn="l" pos="6397560"/>
                <a:tab algn="l" pos="7677000"/>
                <a:tab algn="l" pos="8956800"/>
                <a:tab algn="l" pos="1023624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Comparison of the extent of THP-1 cell adhesion between individual knockdown of either MYB or MLLT3 and their double knockdown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Rectangle 26"/>
          <p:cNvSpPr/>
          <p:nvPr/>
        </p:nvSpPr>
        <p:spPr>
          <a:xfrm>
            <a:off x="1351800" y="9125280"/>
            <a:ext cx="9504720" cy="402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28160" rIns="128160" tIns="64080" bIns="6408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279440"/>
                <a:tab algn="l" pos="2558880"/>
                <a:tab algn="l" pos="3838680"/>
                <a:tab algn="l" pos="5118120"/>
                <a:tab algn="l" pos="6397560"/>
                <a:tab algn="l" pos="7677000"/>
                <a:tab algn="l" pos="8956800"/>
                <a:tab algn="l" pos="1023624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Venn’s diagram of genes affected by knockdown of MYB and MLLT3 and their double knockdown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 Box 24"/>
          <p:cNvSpPr/>
          <p:nvPr/>
        </p:nvSpPr>
        <p:spPr>
          <a:xfrm>
            <a:off x="695160" y="5356080"/>
            <a:ext cx="699120" cy="677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28160" rIns="128160" tIns="64080" bIns="6408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279440"/>
                <a:tab algn="l" pos="2558880"/>
                <a:tab algn="l" pos="3838680"/>
                <a:tab algn="l" pos="5118120"/>
                <a:tab algn="l" pos="6397560"/>
                <a:tab algn="l" pos="7677000"/>
                <a:tab algn="l" pos="8956800"/>
                <a:tab algn="l" pos="1023624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Calibri"/>
              </a:rPr>
              <a:t>S2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 Box 24"/>
          <p:cNvSpPr/>
          <p:nvPr/>
        </p:nvSpPr>
        <p:spPr>
          <a:xfrm>
            <a:off x="695160" y="546120"/>
            <a:ext cx="699120" cy="677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28160" rIns="128160" tIns="64080" bIns="6408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279440"/>
                <a:tab algn="l" pos="2558880"/>
                <a:tab algn="l" pos="3838680"/>
                <a:tab algn="l" pos="5118120"/>
                <a:tab algn="l" pos="6397560"/>
                <a:tab algn="l" pos="7677000"/>
                <a:tab algn="l" pos="8956800"/>
                <a:tab algn="l" pos="1023624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Calibri"/>
              </a:rPr>
              <a:t>S1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テキスト ボックス 23"/>
          <p:cNvSpPr/>
          <p:nvPr/>
        </p:nvSpPr>
        <p:spPr>
          <a:xfrm>
            <a:off x="76680" y="12600"/>
            <a:ext cx="275184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Calibri"/>
                <a:ea typeface="ヒラギノ角ゴ ProN"/>
              </a:rPr>
              <a:t>Additional data file 8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8-12T07:18:51Z</dcterms:created>
  <dc:creator>外丸 靖浩</dc:creator>
  <dc:description/>
  <dc:language>en-US</dc:language>
  <cp:lastModifiedBy>外丸 靖浩</cp:lastModifiedBy>
  <dcterms:modified xsi:type="dcterms:W3CDTF">2009-10-23T09:00:44Z</dcterms:modified>
  <cp:revision>6</cp:revision>
  <dc:subject/>
  <dc:title>スライド 1</dc:title>
</cp:coreProperties>
</file>